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84" r:id="rId1"/>
  </p:sldMasterIdLst>
  <p:sldIdLst>
    <p:sldId id="268" r:id="rId2"/>
    <p:sldId id="270" r:id="rId3"/>
    <p:sldId id="269" r:id="rId4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>
        <p:scale>
          <a:sx n="125" d="100"/>
          <a:sy n="125" d="100"/>
        </p:scale>
        <p:origin x="312" y="-11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0767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3886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74164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8473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9144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112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7864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225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539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8771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4303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88202-BD4F-4942-A2D2-55079D930011}" type="datetimeFigureOut">
              <a:rPr lang="zh-CN" altLang="en-US" smtClean="0"/>
              <a:t>2023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922E7-BF58-457C-8C1C-FBA06BFE48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0552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2ADFE570-0A12-B34F-DD3C-53D40E83B585}"/>
              </a:ext>
            </a:extLst>
          </p:cNvPr>
          <p:cNvGrpSpPr/>
          <p:nvPr/>
        </p:nvGrpSpPr>
        <p:grpSpPr>
          <a:xfrm>
            <a:off x="1829231" y="1746931"/>
            <a:ext cx="5341075" cy="4114995"/>
            <a:chOff x="1829231" y="1746931"/>
            <a:chExt cx="5341075" cy="4114995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8C278FEE-9C80-9A52-454A-22583B569D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1829231" y="1746931"/>
              <a:ext cx="5341075" cy="3705450"/>
            </a:xfrm>
            <a:prstGeom prst="rect">
              <a:avLst/>
            </a:prstGeom>
            <a:noFill/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2F6A4C52-342A-4D66-BEA5-CB167C6C456C}"/>
                </a:ext>
              </a:extLst>
            </p:cNvPr>
            <p:cNvSpPr txBox="1"/>
            <p:nvPr/>
          </p:nvSpPr>
          <p:spPr>
            <a:xfrm>
              <a:off x="2087905" y="5354095"/>
              <a:ext cx="4679348" cy="5078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S1. Theoretical Distribution Curve of 2MG-AD, The red line is the theoretical distribution curve of the optimal genetic model, and the remaining light lines represent the theoretical distribution curves of the remaining genetic models, respectively.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811897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A8BA504B-9450-63C2-F4E2-2A50CCCE109F}"/>
              </a:ext>
            </a:extLst>
          </p:cNvPr>
          <p:cNvGrpSpPr/>
          <p:nvPr/>
        </p:nvGrpSpPr>
        <p:grpSpPr>
          <a:xfrm>
            <a:off x="963404" y="505326"/>
            <a:ext cx="6164104" cy="5891433"/>
            <a:chOff x="963404" y="505326"/>
            <a:chExt cx="6164104" cy="5891433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8DB5ED8E-750E-A4EE-9C69-ED621652C39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31877" y="505326"/>
              <a:ext cx="4988173" cy="4783755"/>
            </a:xfrm>
            <a:prstGeom prst="rect">
              <a:avLst/>
            </a:prstGeom>
            <a:noFill/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AD11DFDE-DD99-48A3-826E-650E6B1A41AC}"/>
                </a:ext>
              </a:extLst>
            </p:cNvPr>
            <p:cNvSpPr txBox="1"/>
            <p:nvPr/>
          </p:nvSpPr>
          <p:spPr>
            <a:xfrm>
              <a:off x="963404" y="5196430"/>
              <a:ext cx="6164104" cy="12003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S2. Visualization of </a:t>
              </a:r>
              <a:r>
                <a:rPr lang="en-US" altLang="zh-CN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sample</a:t>
              </a:r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sults Distribution on Chromosomes (SNP).</a:t>
              </a:r>
              <a:r>
                <a:rPr lang="en-US" altLang="zh-CN" sz="900" dirty="0">
                  <a:solidFill>
                    <a:srgbClr val="37415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 outer to inner circles, the following information is presented. Chromosome Coordinates: The outermost circle displays the coordinates of the chromosomes. Gene Distribution: The second circle represents the distribution of genes along the chromosomes. SNP Density Distribution: The third circle indicates the distribution pattern of SNP densities across the chromosomes. SNP-ED Value Distribution: The fourth circle provides the distribution of SNP-ED (SNP-Endosperm Differences) values, which are indicative of genetic variations. ΔSNP-index Value Distribution: The innermost circle represents the distribution of ΔSNP-index values, reflecting the relative differences in SNP indices between samples.</a:t>
              </a:r>
            </a:p>
            <a:p>
              <a:pPr algn="l"/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66727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09A4CE2-4EEF-3CA9-9AA1-E616BB05C618}"/>
              </a:ext>
            </a:extLst>
          </p:cNvPr>
          <p:cNvSpPr txBox="1"/>
          <p:nvPr/>
        </p:nvSpPr>
        <p:spPr>
          <a:xfrm>
            <a:off x="1793627" y="1303744"/>
            <a:ext cx="459765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9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Primer sequences used for localization in this study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0436BE32-3F11-2972-FEB0-31429E120C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7187700"/>
              </p:ext>
            </p:extLst>
          </p:nvPr>
        </p:nvGraphicFramePr>
        <p:xfrm>
          <a:off x="1086275" y="1622357"/>
          <a:ext cx="6019063" cy="4606052"/>
        </p:xfrm>
        <a:graphic>
          <a:graphicData uri="http://schemas.openxmlformats.org/drawingml/2006/table">
            <a:tbl>
              <a:tblPr/>
              <a:tblGrid>
                <a:gridCol w="897353">
                  <a:extLst>
                    <a:ext uri="{9D8B030D-6E8A-4147-A177-3AD203B41FA5}">
                      <a16:colId xmlns:a16="http://schemas.microsoft.com/office/drawing/2014/main" val="1548356032"/>
                    </a:ext>
                  </a:extLst>
                </a:gridCol>
                <a:gridCol w="1040270">
                  <a:extLst>
                    <a:ext uri="{9D8B030D-6E8A-4147-A177-3AD203B41FA5}">
                      <a16:colId xmlns:a16="http://schemas.microsoft.com/office/drawing/2014/main" val="78881829"/>
                    </a:ext>
                  </a:extLst>
                </a:gridCol>
                <a:gridCol w="2020811">
                  <a:extLst>
                    <a:ext uri="{9D8B030D-6E8A-4147-A177-3AD203B41FA5}">
                      <a16:colId xmlns:a16="http://schemas.microsoft.com/office/drawing/2014/main" val="2322231898"/>
                    </a:ext>
                  </a:extLst>
                </a:gridCol>
                <a:gridCol w="2060629">
                  <a:extLst>
                    <a:ext uri="{9D8B030D-6E8A-4147-A177-3AD203B41FA5}">
                      <a16:colId xmlns:a16="http://schemas.microsoft.com/office/drawing/2014/main" val="3090926240"/>
                    </a:ext>
                  </a:extLst>
                </a:gridCol>
              </a:tblGrid>
              <a:tr h="2769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rimer Name</a:t>
                      </a:r>
                      <a:endParaRPr lang="zh-CN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ysical Location</a:t>
                      </a:r>
                      <a:endParaRPr lang="zh-CN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orward Primer</a:t>
                      </a:r>
                      <a:endParaRPr lang="zh-CN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verse Primer</a:t>
                      </a:r>
                      <a:endParaRPr lang="zh-CN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9033370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85615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GTGTCCCTTGTTACTTAG 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TCTTACCGTGAAAGATTTA 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0802145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453860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ATTGCGTCACTTTGTTTCT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CCACTCCCATCTATCTGTA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0592095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1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71443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GCCTCAACTGGCTCTGTAT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GCACTTTCGATGGTAAACG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675329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67511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AGGAGGTTTGGTTCAGCA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AGTCGGTTAGTTTCGTTTT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9572267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72227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TACTGTAAGAATTTCCCC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GACTCTGACGATAATGTCA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2738578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31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81150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GAAGGAAATGTCTGATGCG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ATAATGATCGTTTTACAAGTT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0804221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3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82464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TTTCTCCTTGGCGATAATA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GCAAGACAGTGGTTGATTA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5996923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3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86421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AGAAAACCCCAAAACCTAA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ATGCGTACCCAGCTATTT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9411324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3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92038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TCCTACGCTCTTCATCTG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GTTGATTGTGAATGTGCG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2480030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94407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CGATAAGAACTGGATGGC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CGCTGTTGTTTGCTCACT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3115933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37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98588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TTGAGGACAGGCAAAGAGC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GGCACTGAATTTCTTTTCAC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0089805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3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996653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ATAAGTTTCTTTCTCGCCATT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TGAGATGCTCCCTCTGGTT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2245519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8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042332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AACAGAAAGTCATAGCACCAG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GCGGATACATCAGTAAGTAGAAT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6240170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2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069299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CTACTTGCCTAATTTTGAT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AGTGGGGATACATGGTTAT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2830067"/>
                  </a:ext>
                </a:extLst>
              </a:tr>
              <a:tr h="2701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5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19902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GATCTACTAACTACAGCGAATT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ATAAGCACAAACCATAGCC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6817210"/>
                  </a:ext>
                </a:extLst>
              </a:tr>
              <a:tr h="2769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WN4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076086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TACTTATTTCTGCCAAGG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CAAAACCAAATACTCCTC </a:t>
                      </a:r>
                    </a:p>
                  </a:txBody>
                  <a:tcPr marL="4763" marR="4763" marT="47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92939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55272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666</TotalTime>
  <Words>247</Words>
  <Application>Microsoft Office PowerPoint</Application>
  <PresentationFormat>Custom</PresentationFormat>
  <Paragraphs>7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主题​​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999131334@qq.com</dc:creator>
  <cp:lastModifiedBy>MDPI</cp:lastModifiedBy>
  <cp:revision>45</cp:revision>
  <dcterms:created xsi:type="dcterms:W3CDTF">2023-08-08T14:32:32Z</dcterms:created>
  <dcterms:modified xsi:type="dcterms:W3CDTF">2023-12-26T01:39:08Z</dcterms:modified>
</cp:coreProperties>
</file>